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4DA53-86E7-423A-A2CC-B3A29505AD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357BD-14E3-4C79-A6BB-F61F1C66BA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1BD18B-383D-4876-BEFC-7922359BECE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92A7F-7D92-405E-A9DA-97E827B30B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2C096-9AD5-4C83-AC84-CC7486F1BE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13A358-2383-4D7E-9229-8B491033AD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04443-E6F5-47A1-AF06-E9154553F4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6474B2-5DF0-4DF9-9A7E-0C1BD3B67D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21B435-396A-4BC4-896C-C85B102362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866BF-B278-4C07-8898-6C567DACC9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874B78-0E97-4339-B611-981180F5CE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42AA39-1719-402A-BF55-83CD3CD097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EFBE12-62CD-4ECB-9FD7-2950206BE28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121280" y="324000"/>
            <a:ext cx="2116080" cy="739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4080" rIns="64080" tIns="32040" bIns="32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Identification in the different sources searched for the period 2000-200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100" spc="-1" strike="noStrike">
                <a:solidFill>
                  <a:srgbClr val="000000"/>
                </a:solidFill>
                <a:latin typeface="Arial"/>
              </a:rPr>
              <a:t>N = 4,862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eferec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122720" y="1900080"/>
            <a:ext cx="2114640" cy="898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4080" rIns="64080" tIns="32040" bIns="32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eading of full text for potentially relevant studi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100" spc="-1" strike="noStrike">
                <a:solidFill>
                  <a:srgbClr val="000000"/>
                </a:solidFill>
                <a:latin typeface="Arial"/>
              </a:rPr>
              <a:t>N = 58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416640" y="952560"/>
            <a:ext cx="1711440" cy="855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4080" rIns="64080" tIns="32040" bIns="32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xclusion of studies after reading the title and abstract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100" spc="-1" strike="noStrike">
                <a:solidFill>
                  <a:srgbClr val="000000"/>
                </a:solidFill>
                <a:latin typeface="Arial"/>
              </a:rPr>
              <a:t>N = 4,27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462720" y="2798640"/>
            <a:ext cx="1746360" cy="855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4080" rIns="64080" tIns="32040" bIns="32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xclusion of irrelevant studies after reading the artic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100" spc="-1" strike="noStrike">
                <a:solidFill>
                  <a:srgbClr val="000000"/>
                </a:solidFill>
                <a:latin typeface="Arial"/>
              </a:rPr>
              <a:t>N = 17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5" name=""/>
          <p:cNvCxnSpPr>
            <a:stCxn id="41" idx="2"/>
            <a:endCxn id="42" idx="0"/>
          </p:cNvCxnSpPr>
          <p:nvPr/>
        </p:nvCxnSpPr>
        <p:spPr>
          <a:xfrm flipH="1" rot="16200000">
            <a:off x="4761720" y="1481400"/>
            <a:ext cx="836640" cy="1080"/>
          </a:xfrm>
          <a:prstGeom prst="bentConnector3">
            <a:avLst>
              <a:gd name="adj1" fmla="val 49978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6" name=""/>
          <p:cNvCxnSpPr>
            <a:stCxn id="41" idx="2"/>
            <a:endCxn id="43" idx="1"/>
          </p:cNvCxnSpPr>
          <p:nvPr/>
        </p:nvCxnSpPr>
        <p:spPr>
          <a:xfrm flipH="1" rot="16200000">
            <a:off x="5639760" y="603000"/>
            <a:ext cx="316800" cy="123768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7" name=""/>
          <p:cNvCxnSpPr>
            <a:stCxn id="42" idx="2"/>
            <a:endCxn id="44" idx="1"/>
          </p:cNvCxnSpPr>
          <p:nvPr/>
        </p:nvCxnSpPr>
        <p:spPr>
          <a:xfrm flipH="1" rot="16200000">
            <a:off x="5607360" y="2370960"/>
            <a:ext cx="428040" cy="128304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8" name=""/>
          <p:cNvSpPr/>
          <p:nvPr/>
        </p:nvSpPr>
        <p:spPr>
          <a:xfrm>
            <a:off x="4111560" y="3922560"/>
            <a:ext cx="2114640" cy="720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4080" rIns="64080" tIns="32040" bIns="32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tudies selected for the period 2000-2008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 = 40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111560" y="5499000"/>
            <a:ext cx="2114640" cy="809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4080" rIns="64080" tIns="32040" bIns="32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tudies included in the systematic review for the period 1983-2008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 = 47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511280" y="303120"/>
            <a:ext cx="2116080" cy="739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4080" rIns="64080" tIns="32040" bIns="32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tudies included in the review previously published for the period 1983-199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100" spc="-1" strike="noStrike">
                <a:solidFill>
                  <a:srgbClr val="000000"/>
                </a:solidFill>
                <a:latin typeface="Arial"/>
              </a:rPr>
              <a:t>N = 87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790560" y="4238640"/>
            <a:ext cx="1484280" cy="944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4080" rIns="64080" tIns="32040" bIns="32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xclusion of studies that fulfilled neither selection criteria nor inclusion criteri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100" spc="-1" strike="noStrike">
                <a:solidFill>
                  <a:srgbClr val="000000"/>
                </a:solidFill>
                <a:latin typeface="Arial"/>
              </a:rPr>
              <a:t>N = 1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511280" y="2933640"/>
            <a:ext cx="2114640" cy="720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64080" rIns="64080" tIns="32040" bIns="320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tudies selected for the period 1983-199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 = 7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" name=""/>
          <p:cNvCxnSpPr>
            <a:stCxn id="50" idx="2"/>
            <a:endCxn id="52" idx="0"/>
          </p:cNvCxnSpPr>
          <p:nvPr/>
        </p:nvCxnSpPr>
        <p:spPr>
          <a:xfrm flipH="1">
            <a:off x="2568600" y="1042920"/>
            <a:ext cx="1080" cy="189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4" name=""/>
          <p:cNvCxnSpPr>
            <a:stCxn id="52" idx="2"/>
            <a:endCxn id="49" idx="1"/>
          </p:cNvCxnSpPr>
          <p:nvPr/>
        </p:nvCxnSpPr>
        <p:spPr>
          <a:xfrm flipH="1" rot="16200000">
            <a:off x="2215440" y="4007520"/>
            <a:ext cx="2249640" cy="154332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5" name=""/>
          <p:cNvCxnSpPr>
            <a:stCxn id="52" idx="2"/>
            <a:endCxn id="51" idx="3"/>
          </p:cNvCxnSpPr>
          <p:nvPr/>
        </p:nvCxnSpPr>
        <p:spPr>
          <a:xfrm rot="5400000">
            <a:off x="1893240" y="4035600"/>
            <a:ext cx="1056960" cy="29412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6" name=""/>
          <p:cNvCxnSpPr>
            <a:stCxn id="42" idx="2"/>
            <a:endCxn id="48" idx="0"/>
          </p:cNvCxnSpPr>
          <p:nvPr/>
        </p:nvCxnSpPr>
        <p:spPr>
          <a:xfrm flipH="1">
            <a:off x="5168880" y="2798640"/>
            <a:ext cx="11520" cy="1124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7" name=""/>
          <p:cNvCxnSpPr>
            <a:stCxn id="48" idx="2"/>
            <a:endCxn id="49" idx="0"/>
          </p:cNvCxnSpPr>
          <p:nvPr/>
        </p:nvCxnSpPr>
        <p:spPr>
          <a:xfrm>
            <a:off x="5168880" y="4643280"/>
            <a:ext cx="360" cy="856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28T16:31:49Z</dcterms:created>
  <dc:creator>Amparo</dc:creator>
  <dc:description/>
  <dc:language>en-US</dc:language>
  <cp:lastModifiedBy>fcatala</cp:lastModifiedBy>
  <dcterms:modified xsi:type="dcterms:W3CDTF">2011-03-03T22:14:29Z</dcterms:modified>
  <cp:revision>8</cp:revision>
  <dc:subject/>
  <dc:title>Diapositiva 1</dc:title>
</cp:coreProperties>
</file>